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5" r:id="rId2"/>
    <p:sldId id="26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53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1253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2886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8918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6879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928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2474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1470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5950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0151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3804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7840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3116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7F219-2D9D-44BD-B06C-A14F3CC5CCF0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5/12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1A050-D9E6-4E51-A7EA-407396AD430B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6579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251520" y="5674603"/>
            <a:ext cx="79928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ummings and </a:t>
            </a:r>
            <a:r>
              <a:rPr lang="en-GB" dirty="0" err="1"/>
              <a:t>Rubino</a:t>
            </a:r>
            <a:r>
              <a:rPr lang="en-GB" dirty="0"/>
              <a:t> (2017) Diabetologia DOI 10.1007/s00125-017-4513-y </a:t>
            </a:r>
          </a:p>
          <a:p>
            <a:r>
              <a:rPr lang="en-GB" sz="1400" dirty="0"/>
              <a:t>© 2016 ADA. Adapted from Cummings and Cohen</a:t>
            </a:r>
          </a:p>
        </p:txBody>
      </p:sp>
      <p:pic>
        <p:nvPicPr>
          <p:cNvPr id="23" name="Picture 22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Odds of diabetes remission or glycaemic control in all 11 randomised clinical trials of surgery vs medical/lifestyle care for type 2 diabet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FEBBCD2-6835-4F91-AD35-598655CDA8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84784"/>
            <a:ext cx="9144000" cy="3734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5010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232552" y="5775225"/>
            <a:ext cx="79928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ummings and </a:t>
            </a:r>
            <a:r>
              <a:rPr lang="en-GB" dirty="0" err="1"/>
              <a:t>Rubino</a:t>
            </a:r>
            <a:r>
              <a:rPr lang="en-GB" dirty="0"/>
              <a:t> (2017) Diabetologia DOI 10.1007/s00125-017-4513-y</a:t>
            </a:r>
          </a:p>
          <a:p>
            <a:r>
              <a:rPr lang="en-GB" sz="1400" dirty="0"/>
              <a:t>© 2016 ADA. Adapted from </a:t>
            </a:r>
            <a:r>
              <a:rPr lang="en-GB" sz="1400" dirty="0" err="1"/>
              <a:t>Rubino</a:t>
            </a:r>
            <a:r>
              <a:rPr lang="en-GB" sz="1400" dirty="0"/>
              <a:t> et al</a:t>
            </a:r>
          </a:p>
        </p:txBody>
      </p:sp>
      <p:pic>
        <p:nvPicPr>
          <p:cNvPr id="23" name="Picture 22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SS-II:  surgery in the type 2 diabetes treatment algorithm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7770" y="1082775"/>
            <a:ext cx="6364484" cy="4346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462842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74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1_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28</cp:revision>
  <dcterms:created xsi:type="dcterms:W3CDTF">2016-06-15T12:53:43Z</dcterms:created>
  <dcterms:modified xsi:type="dcterms:W3CDTF">2017-12-05T09:42:36Z</dcterms:modified>
</cp:coreProperties>
</file>